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06055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71571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9790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17184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75775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1362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81221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62274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42829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3952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47514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82258-8F19-492F-B5DA-E7B7A3528FED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C11D17-7AAB-43A2-ACA0-749A32D2E372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79230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2"/>
          <p:cNvGraphicFramePr>
            <a:graphicFrameLocks noGrp="1"/>
          </p:cNvGraphicFramePr>
          <p:nvPr/>
        </p:nvGraphicFramePr>
        <p:xfrm>
          <a:off x="1470991" y="212029"/>
          <a:ext cx="8320122" cy="6170425"/>
        </p:xfrm>
        <a:graphic>
          <a:graphicData uri="http://schemas.openxmlformats.org/drawingml/2006/table">
            <a:tbl>
              <a:tblPr firstRow="1" firstCol="1" bandRow="1"/>
              <a:tblGrid>
                <a:gridCol w="2699948">
                  <a:extLst>
                    <a:ext uri="{9D8B030D-6E8A-4147-A177-3AD203B41FA5}">
                      <a16:colId xmlns:a16="http://schemas.microsoft.com/office/drawing/2014/main" val="1689531265"/>
                    </a:ext>
                  </a:extLst>
                </a:gridCol>
                <a:gridCol w="1405808">
                  <a:extLst>
                    <a:ext uri="{9D8B030D-6E8A-4147-A177-3AD203B41FA5}">
                      <a16:colId xmlns:a16="http://schemas.microsoft.com/office/drawing/2014/main" val="2691043457"/>
                    </a:ext>
                  </a:extLst>
                </a:gridCol>
                <a:gridCol w="1404279">
                  <a:extLst>
                    <a:ext uri="{9D8B030D-6E8A-4147-A177-3AD203B41FA5}">
                      <a16:colId xmlns:a16="http://schemas.microsoft.com/office/drawing/2014/main" val="3713939092"/>
                    </a:ext>
                  </a:extLst>
                </a:gridCol>
                <a:gridCol w="1405808">
                  <a:extLst>
                    <a:ext uri="{9D8B030D-6E8A-4147-A177-3AD203B41FA5}">
                      <a16:colId xmlns:a16="http://schemas.microsoft.com/office/drawing/2014/main" val="5512622"/>
                    </a:ext>
                  </a:extLst>
                </a:gridCol>
                <a:gridCol w="1404279">
                  <a:extLst>
                    <a:ext uri="{9D8B030D-6E8A-4147-A177-3AD203B41FA5}">
                      <a16:colId xmlns:a16="http://schemas.microsoft.com/office/drawing/2014/main" val="2375081290"/>
                    </a:ext>
                  </a:extLst>
                </a:gridCol>
              </a:tblGrid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del 1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del 2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2217302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eta coefficient (95% CI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eta coefficient (95% CI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C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3944658"/>
                  </a:ext>
                </a:extLst>
              </a:tr>
              <a:tr h="47545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um vs low third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 versus low third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um vs low third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 versus low third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7208666"/>
                  </a:ext>
                </a:extLst>
              </a:tr>
              <a:tr h="47545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pendent variable: HOMA-S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312431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8.7 (-74.0 -23.4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3.8 (-69.5, -18.1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9.0 (-76.3, -21.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4.4 (-78.2, -10.6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2194500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Adiponec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5.7 (-35.6, 24.1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.8 (-13.0, 44.7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8.7 (-38.5, 21.1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.5 (-24.7, 37.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0826490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-Molecular Weight Adiponec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.5 (-32.0, 27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.1 (-14.0, 44.1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3.3 (-44.2, 17.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.4 (-23.4, 36.3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6003435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R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7.7 (-44.6, 9.1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3.5 (-70.5, -16.5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7.1 (-45.7, 11.4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2.2 (-75.5, -8.9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45777"/>
                  </a:ext>
                </a:extLst>
              </a:tr>
              <a:tr h="22720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/HMWA ratio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1.6 (-48.5, 5.2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3.4 (-70.5, -16.3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0.8 (-49.2, 7.6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41.5 (-74.5, -8.4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6130731"/>
                  </a:ext>
                </a:extLst>
              </a:tr>
              <a:tr h="7131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pendent variable: Matsuda index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1658692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.1 (-4.7, -1.5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.1 (-4.8, -1.5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.0 (-4.7, -1.2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.8 (-5.0, -0.6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8323765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Adiponec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1 (-0.8, 3.0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.0 (0.2, 3.9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9 (-1.0, 2.8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3 (-0.6, 3.3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897283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-Molecular Weight Adiponec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8 (-1.1, 2.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7 (-0.2, 3.6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 (-1.9, 2.0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1 (-0.8, 3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763037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R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9 (-2.6, 0.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.5 (-5.2, -1.8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9 (-2.6, 0.9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.3 (-5.4, -1.3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2500203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/HMWA ratio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3 (-3.0, 0.4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3.2 (-5.0, -1.5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2 (-2.9, 0.6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.9 (-5.0, -0.8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2629511"/>
                  </a:ext>
                </a:extLst>
              </a:tr>
              <a:tr h="47545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pendent variable: CSi index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5682478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7 (-4.3, 1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6 (-4.2, 1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7 (-3.5, 2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5 (-2.8, 3.</a:t>
                      </a: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6834166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Adiponec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3 (-2.3, 3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.3 (0.7, 5.9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1 (-2.5, 2.8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.6 (-0.2, 5.4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8676091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-Molecular Weight Adiponectin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0 (-1.9, 3.8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.1 (-0.7, 4.9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01 (-2.9, 2.9) 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3 (-1.4, 4.1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9056708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R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</a:t>
                      </a: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.1 (-3.6, 1.4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.8 (-5.5, -0.1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CL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6 (-3.2, 2.0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5 (-4.8, 1.7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6014427"/>
                  </a:ext>
                </a:extLst>
              </a:tr>
              <a:tr h="2377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eptin/HMWA ratio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2 (-3.8, 1.3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2.5 (-5.2, 0.3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0.7 (-3.3, 1.9)</a:t>
                      </a:r>
                      <a:endParaRPr lang="es-CL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1.1 (-4.3, 2.1)</a:t>
                      </a:r>
                      <a:endParaRPr lang="es-CL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541" marR="6654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421436"/>
                  </a:ext>
                </a:extLst>
              </a:tr>
            </a:tbl>
          </a:graphicData>
        </a:graphic>
      </p:graphicFrame>
      <p:sp>
        <p:nvSpPr>
          <p:cNvPr id="4" name="CuadroTexto 3"/>
          <p:cNvSpPr txBox="1"/>
          <p:nvPr/>
        </p:nvSpPr>
        <p:spPr>
          <a:xfrm>
            <a:off x="9446044" y="6448514"/>
            <a:ext cx="2994991" cy="3710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err="1"/>
              <a:t>Table</a:t>
            </a:r>
            <a:r>
              <a:rPr lang="es-CL" dirty="0"/>
              <a:t> 1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5408821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3</Words>
  <Application>Microsoft Office PowerPoint</Application>
  <PresentationFormat>Panorámica</PresentationFormat>
  <Paragraphs>10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1</cp:revision>
  <dcterms:created xsi:type="dcterms:W3CDTF">2017-03-27T14:50:27Z</dcterms:created>
  <dcterms:modified xsi:type="dcterms:W3CDTF">2017-03-27T14:50:44Z</dcterms:modified>
</cp:coreProperties>
</file>